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3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74" autoAdjust="0"/>
    <p:restoredTop sz="94660"/>
  </p:normalViewPr>
  <p:slideViewPr>
    <p:cSldViewPr snapToGrid="0">
      <p:cViewPr>
        <p:scale>
          <a:sx n="40" d="100"/>
          <a:sy n="40" d="100"/>
        </p:scale>
        <p:origin x="2320" y="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viewProps" Target="viewProps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1F63C5-9497-496B-8507-D51C84DAEA83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3158E2-CD86-48EE-B732-FC2444550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6151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A4131-0050-4A9F-8E5D-3D036A6141D4}" type="datetime1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831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1C7EC-D819-4BF0-9091-BA47A29304E3}" type="datetime1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606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3602F-1256-4B6F-A6A7-38D3862A90E8}" type="datetime1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460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4A9C0-4837-44ED-B605-B21995AC5D2D}" type="datetime1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96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200B8-A08B-4CF2-8D87-782635517CE3}" type="datetime1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154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BF1BB-7238-4458-AEB7-0DF33B6AB56B}" type="datetime1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70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9B75B-B561-4727-88CC-C37F23C6A3D2}" type="datetime1">
              <a:rPr lang="en-US" smtClean="0"/>
              <a:t>5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016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9FF7C-83ED-4500-99A3-A549207CDB30}" type="datetime1">
              <a:rPr lang="en-US" smtClean="0"/>
              <a:t>5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293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723E5-4E54-4263-8537-905F1F0C4095}" type="datetime1">
              <a:rPr lang="en-US" smtClean="0"/>
              <a:t>5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522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98932-197A-4348-AFCC-0D7414C228BC}" type="datetime1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99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937F9-3FF8-4863-843A-A41E8A8AFBE2}" type="datetime1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937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7CA514-8634-4FAC-85C0-59DBD8B4CAD9}" type="datetime1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0F723-AFBF-4798-AA17-5D9ED45B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117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2" Type="http://schemas.openxmlformats.org/officeDocument/2006/relationships/image" Target="../media/image51.emf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2" Type="http://schemas.openxmlformats.org/officeDocument/2006/relationships/image" Target="../media/image53.emf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emf"/><Relationship Id="rId2" Type="http://schemas.openxmlformats.org/officeDocument/2006/relationships/image" Target="../media/image59.emf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圖片 21">
            <a:extLst>
              <a:ext uri="{FF2B5EF4-FFF2-40B4-BE49-F238E27FC236}">
                <a16:creationId xmlns:a16="http://schemas.microsoft.com/office/drawing/2014/main" id="{CB1DFF77-1A92-48E3-93C2-BBEC5980DB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789" y="665433"/>
            <a:ext cx="5925553" cy="3652901"/>
          </a:xfrm>
          <a:prstGeom prst="rect">
            <a:avLst/>
          </a:prstGeom>
        </p:spPr>
      </p:pic>
      <p:pic>
        <p:nvPicPr>
          <p:cNvPr id="32" name="圖片 31">
            <a:extLst>
              <a:ext uri="{FF2B5EF4-FFF2-40B4-BE49-F238E27FC236}">
                <a16:creationId xmlns:a16="http://schemas.microsoft.com/office/drawing/2014/main" id="{BE4124B0-20A8-4934-B220-6381379BE0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699" y="4767989"/>
            <a:ext cx="5880944" cy="3652901"/>
          </a:xfrm>
          <a:prstGeom prst="rect">
            <a:avLst/>
          </a:prstGeom>
        </p:spPr>
      </p:pic>
      <p:sp>
        <p:nvSpPr>
          <p:cNvPr id="25" name="文字方塊 24">
            <a:extLst>
              <a:ext uri="{FF2B5EF4-FFF2-40B4-BE49-F238E27FC236}">
                <a16:creationId xmlns:a16="http://schemas.microsoft.com/office/drawing/2014/main" id="{0FC1D4C4-7831-48D0-AE78-4022819A3BAF}"/>
              </a:ext>
            </a:extLst>
          </p:cNvPr>
          <p:cNvSpPr txBox="1"/>
          <p:nvPr/>
        </p:nvSpPr>
        <p:spPr>
          <a:xfrm>
            <a:off x="1339176" y="436562"/>
            <a:ext cx="44005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ARF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DAVLLVFAN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89.6303, m/z 545.3188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774E7255-9B88-471F-9740-0EC97E866374}"/>
              </a:ext>
            </a:extLst>
          </p:cNvPr>
          <p:cNvSpPr txBox="1"/>
          <p:nvPr/>
        </p:nvSpPr>
        <p:spPr>
          <a:xfrm>
            <a:off x="1386633" y="4558073"/>
            <a:ext cx="43283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RAB8A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TITTAYY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</a:t>
            </a:r>
            <a:r>
              <a:rPr lang="pl-PL" sz="1200" b="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MH+ 988.5098, m/z 494.7585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endParaRPr lang="pl-PL" sz="1200" b="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2CE8487-B684-4493-B830-15749A902C7E}"/>
              </a:ext>
            </a:extLst>
          </p:cNvPr>
          <p:cNvSpPr/>
          <p:nvPr/>
        </p:nvSpPr>
        <p:spPr>
          <a:xfrm>
            <a:off x="594360" y="8630806"/>
            <a:ext cx="56692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1200" b="1" dirty="0"/>
              <a:t>Supplementary Figure S6.</a:t>
            </a:r>
            <a:r>
              <a:rPr lang="en-US" altLang="zh-TW" sz="1200" dirty="0"/>
              <a:t> The spectrum annotation of confident interacting protein identified on basis of a single unique peptide by TPP. The peptide information was labeled on the top of spectra (gene, peptide sequence, MH+, m/z and charge status).</a:t>
            </a:r>
            <a:endParaRPr lang="zh-TW" altLang="zh-TW" sz="1200" dirty="0">
              <a:solidFill>
                <a:srgbClr val="0070C0"/>
              </a:solidFill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55CE26F-4002-4906-AC75-E3F44C0B0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51357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圖片 10">
            <a:extLst>
              <a:ext uri="{FF2B5EF4-FFF2-40B4-BE49-F238E27FC236}">
                <a16:creationId xmlns:a16="http://schemas.microsoft.com/office/drawing/2014/main" id="{63AFEBC7-A11E-41DF-B5D3-AAEEBD2DB5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890" y="5284065"/>
            <a:ext cx="5861666" cy="365760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D903C0C1-F47D-4E25-943B-7B4EE3FC86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486" y="992802"/>
            <a:ext cx="5901070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57DC435F-9A34-48CC-87E7-E841B2888575}"/>
              </a:ext>
            </a:extLst>
          </p:cNvPr>
          <p:cNvSpPr txBox="1"/>
          <p:nvPr/>
        </p:nvSpPr>
        <p:spPr>
          <a:xfrm>
            <a:off x="1233235" y="763931"/>
            <a:ext cx="443363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SDF2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EAHHAEL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877.4163, m/z 439.2118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5DDDE5B5-C347-4643-94DE-8F6BBDA3CDDC}"/>
              </a:ext>
            </a:extLst>
          </p:cNvPr>
          <p:cNvSpPr txBox="1"/>
          <p:nvPr/>
        </p:nvSpPr>
        <p:spPr>
          <a:xfrm>
            <a:off x="1308538" y="5055463"/>
            <a:ext cx="452967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SDF4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YSEFFTGS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65.4888, m/z 533.2480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35325AD2-6C7A-4F55-913B-F85A8B95D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34956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1C8EAE01-F743-4123-A42A-4DBB9C1B73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881" y="1133169"/>
            <a:ext cx="5926238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26BA9D1D-FF5B-4F38-8F92-386D2A3B64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881" y="5498428"/>
            <a:ext cx="5944849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8267A381-E84C-4AA6-B5E5-5D51F32443D7}"/>
              </a:ext>
            </a:extLst>
          </p:cNvPr>
          <p:cNvSpPr txBox="1"/>
          <p:nvPr/>
        </p:nvSpPr>
        <p:spPr>
          <a:xfrm>
            <a:off x="995613" y="856170"/>
            <a:ext cx="48667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solidFill>
                  <a:srgbClr val="000000"/>
                </a:solidFill>
                <a:latin typeface="Trebuchet MS" panose="020B0603020202020204" pitchFamily="34" charset="0"/>
              </a:rPr>
              <a:t>TMEM33, </a:t>
            </a:r>
            <a:r>
              <a:rPr lang="nn-NO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LLANALTSALR</a:t>
            </a:r>
            <a:r>
              <a:rPr lang="nn-NO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213.7263, m/z 607.3668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nn-NO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08ED54D3-E313-49D8-AE96-7222B873E6E1}"/>
              </a:ext>
            </a:extLst>
          </p:cNvPr>
          <p:cNvSpPr txBox="1"/>
          <p:nvPr/>
        </p:nvSpPr>
        <p:spPr>
          <a:xfrm>
            <a:off x="1152023" y="5221429"/>
            <a:ext cx="45539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>
                <a:solidFill>
                  <a:srgbClr val="000000"/>
                </a:solidFill>
                <a:latin typeface="Trebuchet MS" panose="020B0603020202020204" pitchFamily="34" charset="0"/>
              </a:rPr>
              <a:t>MRPL54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TLEELDPES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88.5743, m/z 594.7908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3505EE9F-FC16-4CEA-88FB-9DE7EE89E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14192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14677149-F471-4922-98CC-DF04EDE937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799" y="1097076"/>
            <a:ext cx="5944269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26EF60EB-9AC8-498B-A5D3-9F95043F4E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806" y="5317365"/>
            <a:ext cx="5983346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44E23C39-882E-4A03-9F20-17FAF952E6D9}"/>
              </a:ext>
            </a:extLst>
          </p:cNvPr>
          <p:cNvSpPr txBox="1"/>
          <p:nvPr/>
        </p:nvSpPr>
        <p:spPr>
          <a:xfrm>
            <a:off x="1060784" y="820077"/>
            <a:ext cx="46863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ATP5L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IVNSAQTGSF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51.6055, m/z 576.3064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0DC4429C-399C-45BF-BDFC-503929350B64}"/>
              </a:ext>
            </a:extLst>
          </p:cNvPr>
          <p:cNvSpPr txBox="1"/>
          <p:nvPr/>
        </p:nvSpPr>
        <p:spPr>
          <a:xfrm>
            <a:off x="799096" y="5077994"/>
            <a:ext cx="542022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HIGD1A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STDTGVSLPSYEEDQGS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941.8560, m/z 971.4316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D62B6949-21B8-4BEC-90CA-90CC8F36C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0410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500BFC67-0DF5-4567-A216-ECD43F81CA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823" y="1213380"/>
            <a:ext cx="5906435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AD4193A3-F529-4365-97BD-84DC4F30DE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5409" y="5426528"/>
            <a:ext cx="5922849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3730442A-6110-4C00-ABE2-7D879189DDBF}"/>
              </a:ext>
            </a:extLst>
          </p:cNvPr>
          <p:cNvSpPr txBox="1"/>
          <p:nvPr/>
        </p:nvSpPr>
        <p:spPr>
          <a:xfrm>
            <a:off x="662739" y="936381"/>
            <a:ext cx="556460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UQCRC2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TIAQGNLSNTDVQAA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630.8395, m/z 815.9234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1C412159-0A5F-499B-8C0A-A1F09E9F8C8A}"/>
              </a:ext>
            </a:extLst>
          </p:cNvPr>
          <p:cNvSpPr txBox="1"/>
          <p:nvPr/>
        </p:nvSpPr>
        <p:spPr>
          <a:xfrm>
            <a:off x="1092868" y="5158477"/>
            <a:ext cx="490286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PSMD14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VAVVVDPIQSV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324.7835, m/z 662.8954, charge	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485E23DD-E4BE-4BAC-8E6D-A25BAB219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59429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00B7ACF4-356D-4D19-971C-4DE01B3A62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5171" y="1069004"/>
            <a:ext cx="5969631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C6C2A5D2-E2DA-46B2-B480-C8B8EC8304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171" y="5338954"/>
            <a:ext cx="5922591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7B55C6FA-3BD8-45F3-8F80-1C239BC9A86A}"/>
              </a:ext>
            </a:extLst>
          </p:cNvPr>
          <p:cNvSpPr txBox="1"/>
          <p:nvPr/>
        </p:nvSpPr>
        <p:spPr>
          <a:xfrm>
            <a:off x="1176086" y="792005"/>
            <a:ext cx="460207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PSME2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VEAFQTTIS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23.5994, m/z 562.3033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C78F2CD-0DCD-4730-BF80-50497ADD3156}"/>
              </a:ext>
            </a:extLst>
          </p:cNvPr>
          <p:cNvSpPr txBox="1"/>
          <p:nvPr/>
        </p:nvSpPr>
        <p:spPr>
          <a:xfrm>
            <a:off x="409072" y="5061955"/>
            <a:ext cx="616016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HLA-C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GGSCSQAASSNSAQGSDESLIAC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2372.0088, m/z 791.3411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D25BE44-6B3D-4D06-8CFA-8A0525C9D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06774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36C2A9CD-A954-4544-A5AC-5C80133084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220" y="976760"/>
            <a:ext cx="5901070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F59A67D2-4402-42FA-8A2A-CA25C75318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7279" y="5257798"/>
            <a:ext cx="5956951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DBCAA6BC-6A6D-4DC1-8426-F99BFE30792B}"/>
              </a:ext>
            </a:extLst>
          </p:cNvPr>
          <p:cNvSpPr txBox="1"/>
          <p:nvPr/>
        </p:nvSpPr>
        <p:spPr>
          <a:xfrm>
            <a:off x="1123950" y="699761"/>
            <a:ext cx="481864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SNX3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GDDGIFDDNFIEE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641.7027, m/z 821.3550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0C80739C-BCA3-4D57-A74C-D642906E6650}"/>
              </a:ext>
            </a:extLst>
          </p:cNvPr>
          <p:cNvSpPr txBox="1"/>
          <p:nvPr/>
        </p:nvSpPr>
        <p:spPr>
          <a:xfrm>
            <a:off x="1292391" y="4980799"/>
            <a:ext cx="44817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ARL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ILILGLDGAG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69.6616, m/z 535.3344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49A39618-35E3-44CF-BF8A-1A8908E8D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87621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4841B3BD-05AC-40E8-9329-EED0695CFC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0051" y="904572"/>
            <a:ext cx="5931672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731DA208-9273-47EF-B097-7247779C7D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654" y="5348171"/>
            <a:ext cx="5987111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58D5FDB9-DB06-446A-A180-70EC4DDB7E12}"/>
              </a:ext>
            </a:extLst>
          </p:cNvPr>
          <p:cNvSpPr txBox="1"/>
          <p:nvPr/>
        </p:nvSpPr>
        <p:spPr>
          <a:xfrm>
            <a:off x="1012658" y="627573"/>
            <a:ext cx="47464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SLC20A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LGDLEEAPE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28.5531, m/z 564.780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0B70F419-1656-44F3-A79F-EB30A27044E6}"/>
              </a:ext>
            </a:extLst>
          </p:cNvPr>
          <p:cNvSpPr txBox="1"/>
          <p:nvPr/>
        </p:nvSpPr>
        <p:spPr>
          <a:xfrm>
            <a:off x="1172076" y="5071172"/>
            <a:ext cx="467426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DDX28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VGIFQSFQ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53.5728, m/z 527.2900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DFB4C984-197E-4998-8B3E-9A37CBF82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68550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A3A56672-A06E-4B39-97AB-7C52CA6B32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6293" y="924624"/>
            <a:ext cx="5945833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E91C1207-6C7A-44A9-8909-8D79685601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6293" y="5332129"/>
            <a:ext cx="5920877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C815403E-A2AD-4CBF-98C5-726C827C5BB6}"/>
              </a:ext>
            </a:extLst>
          </p:cNvPr>
          <p:cNvSpPr txBox="1"/>
          <p:nvPr/>
        </p:nvSpPr>
        <p:spPr>
          <a:xfrm>
            <a:off x="964530" y="647625"/>
            <a:ext cx="474645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PSMA5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GVNTFSPEG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63.5167, m/z 532.2620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C1F5AB5A-C275-4930-ABAC-F6C346BD2C79}"/>
              </a:ext>
            </a:extLst>
          </p:cNvPr>
          <p:cNvSpPr txBox="1"/>
          <p:nvPr/>
        </p:nvSpPr>
        <p:spPr>
          <a:xfrm>
            <a:off x="1304421" y="5055130"/>
            <a:ext cx="44095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TGFBR2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DIFSDINL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64.5623, m/z 532.7848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AA0B414-C175-4526-B0FB-B7C4EE71A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70545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0B5DD5CF-EADF-4830-A375-A41708660F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321" y="892540"/>
            <a:ext cx="6007184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79E185B2-490E-4FAA-AFA5-2CA42EAFBF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833" y="5305924"/>
            <a:ext cx="5931672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07E2182D-4BDB-42E2-AE62-46110AAEA59B}"/>
              </a:ext>
            </a:extLst>
          </p:cNvPr>
          <p:cNvSpPr txBox="1"/>
          <p:nvPr/>
        </p:nvSpPr>
        <p:spPr>
          <a:xfrm>
            <a:off x="1112923" y="615541"/>
            <a:ext cx="47103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ARF4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DAVLLLFAN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03.6459, m/z 552.3266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FD2D6825-7194-40FA-9F3A-608123BE1D22}"/>
              </a:ext>
            </a:extLst>
          </p:cNvPr>
          <p:cNvSpPr txBox="1"/>
          <p:nvPr/>
        </p:nvSpPr>
        <p:spPr>
          <a:xfrm>
            <a:off x="1112923" y="5028925"/>
            <a:ext cx="484743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RHOBTB3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DSGDVSNVIE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62.5586, m/z 581.7829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8222183-BFE6-4744-8A4D-4F706E979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76619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23B7E199-E015-4286-9CD8-0A249DBC2F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147" y="976761"/>
            <a:ext cx="5876014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AFD53560-389B-47E0-8878-E04DC319ED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7147" y="5188359"/>
            <a:ext cx="5935579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8D1F7506-537A-4BAD-96CE-9A847CFF9FD0}"/>
              </a:ext>
            </a:extLst>
          </p:cNvPr>
          <p:cNvSpPr txBox="1"/>
          <p:nvPr/>
        </p:nvSpPr>
        <p:spPr>
          <a:xfrm>
            <a:off x="921417" y="699762"/>
            <a:ext cx="51435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rebuchet MS" panose="020B0603020202020204" pitchFamily="34" charset="0"/>
              </a:rPr>
              <a:t>S100A13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SLDVNQDSEL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247.6114, m/z 624.3093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5355FE62-29ED-42B4-85CE-685085B0BB57}"/>
              </a:ext>
            </a:extLst>
          </p:cNvPr>
          <p:cNvSpPr txBox="1"/>
          <p:nvPr/>
        </p:nvSpPr>
        <p:spPr>
          <a:xfrm>
            <a:off x="1053764" y="4911360"/>
            <a:ext cx="487880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SEC23A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MVVPVAALFTPL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385.8225, m/z 693.4149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2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AE1EC0B-4F7A-4670-9F1C-53F23B731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4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圖片 12">
            <a:extLst>
              <a:ext uri="{FF2B5EF4-FFF2-40B4-BE49-F238E27FC236}">
                <a16:creationId xmlns:a16="http://schemas.microsoft.com/office/drawing/2014/main" id="{68FD9F3A-8F88-48A1-869A-22F28D405B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0208" y="5401686"/>
            <a:ext cx="5937584" cy="3692302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38559652-0EF6-4A39-86EB-D7866AFCFF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208" y="1076895"/>
            <a:ext cx="5937584" cy="3660082"/>
          </a:xfrm>
          <a:prstGeom prst="rect">
            <a:avLst/>
          </a:prstGeom>
        </p:spPr>
      </p:pic>
      <p:sp>
        <p:nvSpPr>
          <p:cNvPr id="11" name="文字方塊 10">
            <a:extLst>
              <a:ext uri="{FF2B5EF4-FFF2-40B4-BE49-F238E27FC236}">
                <a16:creationId xmlns:a16="http://schemas.microsoft.com/office/drawing/2014/main" id="{A5C86469-EB91-44B8-82D4-3413A2A1A190}"/>
              </a:ext>
            </a:extLst>
          </p:cNvPr>
          <p:cNvSpPr txBox="1"/>
          <p:nvPr/>
        </p:nvSpPr>
        <p:spPr>
          <a:xfrm>
            <a:off x="1419726" y="799896"/>
            <a:ext cx="4343400" cy="27699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MET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QAISSTVLG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03.5782, m/z 502.2928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CA203BE3-F70C-4888-B8A7-87D895C9F626}"/>
              </a:ext>
            </a:extLst>
          </p:cNvPr>
          <p:cNvSpPr txBox="1"/>
          <p:nvPr/>
        </p:nvSpPr>
        <p:spPr>
          <a:xfrm>
            <a:off x="1221205" y="5187587"/>
            <a:ext cx="4541921" cy="27699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TMEM59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YPASSLVVV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90.6255, m/z 545.8164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C588D8DC-8674-4EB2-B93D-8F7429005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35264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C76A4588-FB93-4C0C-AF5B-44E7DBC6F6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4189" y="984782"/>
            <a:ext cx="5879804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27EC7A30-E804-43EE-8FB0-E6D4B26955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189" y="5241756"/>
            <a:ext cx="5896906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2732FFCD-475C-4CFA-B1B0-33A87D2579B6}"/>
              </a:ext>
            </a:extLst>
          </p:cNvPr>
          <p:cNvSpPr txBox="1"/>
          <p:nvPr/>
        </p:nvSpPr>
        <p:spPr>
          <a:xfrm>
            <a:off x="1181099" y="707783"/>
            <a:ext cx="456598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>
                <a:solidFill>
                  <a:srgbClr val="000000"/>
                </a:solidFill>
                <a:latin typeface="Trebuchet MS" panose="020B0603020202020204" pitchFamily="34" charset="0"/>
              </a:rPr>
              <a:t>POM121C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ETVLSAL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860.5088, m/z 430.7580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12F3C089-0653-47D4-9D31-3622A2BB6FB0}"/>
              </a:ext>
            </a:extLst>
          </p:cNvPr>
          <p:cNvSpPr txBox="1"/>
          <p:nvPr/>
        </p:nvSpPr>
        <p:spPr>
          <a:xfrm>
            <a:off x="1421730" y="4964757"/>
            <a:ext cx="465020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SNX27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QAVPISVP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966.5731, m/z 483.790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89A02970-4F60-4379-B871-B4AD2C1A0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04194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E2C52611-35B0-451C-928D-2E7FFF6B05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147" y="1010651"/>
            <a:ext cx="5926914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386AACE3-9751-4195-AD21-F9906408F2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1706" y="5224055"/>
            <a:ext cx="5877795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D8FA2A4E-7B90-4F72-8A50-B63E8E907AE1}"/>
              </a:ext>
            </a:extLst>
          </p:cNvPr>
          <p:cNvSpPr txBox="1"/>
          <p:nvPr/>
        </p:nvSpPr>
        <p:spPr>
          <a:xfrm>
            <a:off x="921417" y="731846"/>
            <a:ext cx="5143501" cy="2788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GNAI2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IAQSDYIPTQQDVL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746.9021, m/z 873.9547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B4B213B6-AB36-4DE9-872F-797056F5DDD8}"/>
              </a:ext>
            </a:extLst>
          </p:cNvPr>
          <p:cNvSpPr txBox="1"/>
          <p:nvPr/>
        </p:nvSpPr>
        <p:spPr>
          <a:xfrm>
            <a:off x="1113922" y="4947056"/>
            <a:ext cx="49509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CDHGC3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YAELVLE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992.5411, m/z 496.774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sz="1200" dirty="0">
                <a:solidFill>
                  <a:srgbClr val="000000"/>
                </a:solidFill>
                <a:latin typeface="Trebuchet MS" panose="020B0603020202020204" pitchFamily="34" charset="0"/>
              </a:rPr>
              <a:t>: 2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B285FCE0-C9EC-41A0-987E-FE70ADE02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28424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圖片 12">
            <a:extLst>
              <a:ext uri="{FF2B5EF4-FFF2-40B4-BE49-F238E27FC236}">
                <a16:creationId xmlns:a16="http://schemas.microsoft.com/office/drawing/2014/main" id="{5EA529FA-B7C0-4C09-8B1D-D5EDA968C1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124" y="1081035"/>
            <a:ext cx="5900644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C0A674B5-4ACC-4B20-91AA-74D0A19984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831" y="5428381"/>
            <a:ext cx="5946274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38241788-E37D-42D1-BE54-8F16DF24E36A}"/>
              </a:ext>
            </a:extLst>
          </p:cNvPr>
          <p:cNvSpPr txBox="1"/>
          <p:nvPr/>
        </p:nvSpPr>
        <p:spPr>
          <a:xfrm>
            <a:off x="450832" y="804036"/>
            <a:ext cx="62347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ZYX</a:t>
            </a:r>
            <a:r>
              <a:rPr lang="en-US" sz="1200" i="0" strike="noStrike" baseline="0" dirty="0">
                <a:latin typeface="Trebuchet MS" panose="020B0603020202020204" pitchFamily="34" charset="0"/>
              </a:rPr>
              <a:t>, </a:t>
            </a:r>
            <a:r>
              <a:rPr lang="en-US" sz="1200" i="0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QHPVPPPAQNQNQVR</a:t>
            </a:r>
            <a:r>
              <a:rPr lang="en-US" sz="1200" i="0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1692.8564, m/z 846.9319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CCCFE183-D4BE-40E7-92EE-601F68EBE4F1}"/>
              </a:ext>
            </a:extLst>
          </p:cNvPr>
          <p:cNvSpPr txBox="1"/>
          <p:nvPr/>
        </p:nvSpPr>
        <p:spPr>
          <a:xfrm>
            <a:off x="1048752" y="5151382"/>
            <a:ext cx="525178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ERRFI1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LTVNGV</a:t>
            </a:r>
            <a:r>
              <a:rPr lang="en-US" sz="1200" i="0" u="sng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C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STPPLTPI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767.9673, m/z 884.4873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86A25503-DDC5-46F9-95B8-8481B0D1A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2167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A9FCA3EC-BC11-4319-A40F-5CD1ADF50B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0142" y="984782"/>
            <a:ext cx="5877715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7804DED7-6A25-48B9-B3A4-27A9614171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0142" y="5372298"/>
            <a:ext cx="5964122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BD503D23-ED40-45D7-B3BF-C5C9A72624FB}"/>
              </a:ext>
            </a:extLst>
          </p:cNvPr>
          <p:cNvSpPr txBox="1"/>
          <p:nvPr/>
        </p:nvSpPr>
        <p:spPr>
          <a:xfrm>
            <a:off x="1221206" y="707783"/>
            <a:ext cx="462614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FHL3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RPIVGLGGG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953.5891, m/z 477.298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D742B442-3379-45DE-A4B1-ADBCCE000DEB}"/>
              </a:ext>
            </a:extLst>
          </p:cNvPr>
          <p:cNvSpPr txBox="1"/>
          <p:nvPr/>
        </p:nvSpPr>
        <p:spPr>
          <a:xfrm>
            <a:off x="857249" y="5095299"/>
            <a:ext cx="51435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ITGB4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DVVSFEQPEFSVS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625.7806, m/z 813.3939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B22C1560-326F-4C1C-8129-BB3568FF37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16162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C8A5608F-C881-4BD1-BE8D-BB3D00C065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6994" y="956708"/>
            <a:ext cx="5909817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2BAAF7E5-52E6-4C2A-9DB2-E456EA17F7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6994" y="5257798"/>
            <a:ext cx="5950124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32D15092-F955-48E8-9B27-4E262F634AC2}"/>
              </a:ext>
            </a:extLst>
          </p:cNvPr>
          <p:cNvSpPr txBox="1"/>
          <p:nvPr/>
        </p:nvSpPr>
        <p:spPr>
          <a:xfrm>
            <a:off x="1078832" y="679709"/>
            <a:ext cx="462614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LSR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DTDSSVASEV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65.5331, m/z 583.270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3EA7241F-3349-4E2A-A604-36E183C11C4D}"/>
              </a:ext>
            </a:extLst>
          </p:cNvPr>
          <p:cNvSpPr txBox="1"/>
          <p:nvPr/>
        </p:nvSpPr>
        <p:spPr>
          <a:xfrm>
            <a:off x="1078832" y="4948715"/>
            <a:ext cx="49750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GNAS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QADYVPSDQDLL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519.7387, m/z 760.3730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44849AE-56E7-4EEF-9A27-B02E09532F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50284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CAB5A427-8A11-4B61-9B42-06D7350B89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597" y="1008845"/>
            <a:ext cx="5912887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894ABBE2-0FC2-4302-A87E-F2275E850E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597" y="5194575"/>
            <a:ext cx="5926035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A1F3255D-F84C-4250-B50F-0743ACE1E755}"/>
              </a:ext>
            </a:extLst>
          </p:cNvPr>
          <p:cNvSpPr txBox="1"/>
          <p:nvPr/>
        </p:nvSpPr>
        <p:spPr>
          <a:xfrm>
            <a:off x="951497" y="731846"/>
            <a:ext cx="498708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strike="noStrike" baseline="0" dirty="0">
                <a:latin typeface="Trebuchet MS" panose="020B0603020202020204" pitchFamily="34" charset="0"/>
              </a:rPr>
              <a:t>CDC37, </a:t>
            </a:r>
            <a:r>
              <a:rPr lang="en-US" sz="1200" i="0" u="sng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C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IDSGLWVPNS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375.6674, m/z 688.3373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BC84DB58-B147-4808-90B7-6D3279AC499A}"/>
              </a:ext>
            </a:extLst>
          </p:cNvPr>
          <p:cNvSpPr txBox="1"/>
          <p:nvPr/>
        </p:nvSpPr>
        <p:spPr>
          <a:xfrm>
            <a:off x="1026694" y="4943444"/>
            <a:ext cx="51435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1200" i="0" u="none" strike="noStrike" baseline="0" dirty="0">
                <a:latin typeface="Trebuchet MS" panose="020B0603020202020204" pitchFamily="34" charset="0"/>
              </a:rPr>
              <a:t>RNF149, </a:t>
            </a:r>
            <a:r>
              <a:rPr lang="sv-SE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GAAPWVALVAR</a:t>
            </a:r>
            <a:r>
              <a:rPr lang="sv-SE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10.6418, m/z 555.8246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sv-SE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71E672BD-F968-483C-AD95-4075E3D03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4826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AB05371C-D0BD-4FE7-96F4-7708606D59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8198" y="976760"/>
            <a:ext cx="5941603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D38F8D97-FA1E-40E4-80E2-F71B6FFE77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6451" y="5257798"/>
            <a:ext cx="5943350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9F3E1EB7-DE20-4623-A5D8-125129121787}"/>
              </a:ext>
            </a:extLst>
          </p:cNvPr>
          <p:cNvSpPr txBox="1"/>
          <p:nvPr/>
        </p:nvSpPr>
        <p:spPr>
          <a:xfrm>
            <a:off x="944479" y="699761"/>
            <a:ext cx="473442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WWP2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GVALPFE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931.5247, m/z 466.2660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sz="1200" dirty="0">
                <a:solidFill>
                  <a:srgbClr val="000000"/>
                </a:solidFill>
                <a:latin typeface="Trebuchet MS" panose="020B0603020202020204" pitchFamily="34" charset="0"/>
              </a:rPr>
              <a:t>: 2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3CD5A14F-9B16-46C5-9A58-64F235C0E1A0}"/>
              </a:ext>
            </a:extLst>
          </p:cNvPr>
          <p:cNvSpPr txBox="1"/>
          <p:nvPr/>
        </p:nvSpPr>
        <p:spPr>
          <a:xfrm>
            <a:off x="1027701" y="4980799"/>
            <a:ext cx="49389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EFCAB1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HIFTAFDTYY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433.6848, m/z 717.3461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2D41DD2-F405-4BDD-9FCD-5453BD433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78508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9503A01A-492A-44A4-9056-8983195DAD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928" y="988792"/>
            <a:ext cx="5986009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8863E7A0-48F9-43A2-B575-FF4C2C63F8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991" y="5348171"/>
            <a:ext cx="5940102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5A2DCD92-A8DC-4389-BBFF-E98B72ABCD07}"/>
              </a:ext>
            </a:extLst>
          </p:cNvPr>
          <p:cNvSpPr txBox="1"/>
          <p:nvPr/>
        </p:nvSpPr>
        <p:spPr>
          <a:xfrm>
            <a:off x="975560" y="711793"/>
            <a:ext cx="49389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SPTLC1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VVVTVEQTEEELE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659.8436, m/z 830.4254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6C391DC2-184A-4ACA-A9A1-122DAFDB4B7A}"/>
              </a:ext>
            </a:extLst>
          </p:cNvPr>
          <p:cNvSpPr txBox="1"/>
          <p:nvPr/>
        </p:nvSpPr>
        <p:spPr>
          <a:xfrm>
            <a:off x="1297405" y="5071172"/>
            <a:ext cx="48066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200" i="0" u="none" strike="noStrike" baseline="0" dirty="0">
                <a:latin typeface="Trebuchet MS" panose="020B0603020202020204" pitchFamily="34" charset="0"/>
              </a:rPr>
              <a:t>TECR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HYEVEILDA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216.6208, m/z 608.8141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871F6BD5-B559-4DFB-A6EC-181FDEDDA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49264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3540731E-1424-40F5-AE05-155A91DAC6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923" y="1036918"/>
            <a:ext cx="5958154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9F1E3B09-054D-44A5-BE7A-98FBFA4719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3228" y="5354050"/>
            <a:ext cx="5944849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61676F45-9F3E-454D-9AF6-E98E25889A90}"/>
              </a:ext>
            </a:extLst>
          </p:cNvPr>
          <p:cNvSpPr txBox="1"/>
          <p:nvPr/>
        </p:nvSpPr>
        <p:spPr>
          <a:xfrm>
            <a:off x="971550" y="759919"/>
            <a:ext cx="49149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l-PL" sz="1200" i="0" u="none" strike="noStrike" baseline="0" dirty="0">
                <a:latin typeface="Trebuchet MS" panose="020B0603020202020204" pitchFamily="34" charset="0"/>
              </a:rPr>
              <a:t>ZDHHC13</a:t>
            </a:r>
            <a:r>
              <a:rPr lang="en-US" sz="1200" i="0" u="none" strike="noStrike" baseline="0" dirty="0">
                <a:latin typeface="Trebuchet MS" panose="020B0603020202020204" pitchFamily="34" charset="0"/>
              </a:rPr>
              <a:t>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FNPSLNVVD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32.5997, m/z 566.8035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B4BA052D-FA9C-44F0-909B-3622D08C60C0}"/>
              </a:ext>
            </a:extLst>
          </p:cNvPr>
          <p:cNvSpPr txBox="1"/>
          <p:nvPr/>
        </p:nvSpPr>
        <p:spPr>
          <a:xfrm>
            <a:off x="857250" y="5077051"/>
            <a:ext cx="51435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l-PL" sz="1200" i="0" u="none" strike="noStrike" baseline="0" dirty="0">
                <a:latin typeface="Trebuchet MS" panose="020B0603020202020204" pitchFamily="34" charset="0"/>
              </a:rPr>
              <a:t>IFITM3</a:t>
            </a:r>
            <a:r>
              <a:rPr lang="en-US" sz="1200" i="0" u="none" strike="noStrike" baseline="0" dirty="0">
                <a:latin typeface="Trebuchet MS" panose="020B0603020202020204" pitchFamily="34" charset="0"/>
              </a:rPr>
              <a:t>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MVGDVTGAQAYASTA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569.7577, m/z 785.3825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D4CB4EB2-B7A1-4E3F-BF77-B6C36DE78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07801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圖片 14">
            <a:extLst>
              <a:ext uri="{FF2B5EF4-FFF2-40B4-BE49-F238E27FC236}">
                <a16:creationId xmlns:a16="http://schemas.microsoft.com/office/drawing/2014/main" id="{4C27F590-397B-4873-952F-121D0313D9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882" y="5258740"/>
            <a:ext cx="5966745" cy="365760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D45795B8-A483-4C42-8B50-2937B1F23B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5457" y="1024886"/>
            <a:ext cx="5919170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9023DF5F-F990-42DD-9D7C-5B7BE06340AA}"/>
              </a:ext>
            </a:extLst>
          </p:cNvPr>
          <p:cNvSpPr txBox="1"/>
          <p:nvPr/>
        </p:nvSpPr>
        <p:spPr>
          <a:xfrm>
            <a:off x="1153027" y="747887"/>
            <a:ext cx="479458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DDR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NLYAGDYY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34.5214, m/z 567.7644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A6DF67BA-885F-4B8F-B1C8-C6F1CAFE6FD4}"/>
              </a:ext>
            </a:extLst>
          </p:cNvPr>
          <p:cNvSpPr txBox="1"/>
          <p:nvPr/>
        </p:nvSpPr>
        <p:spPr>
          <a:xfrm>
            <a:off x="1080839" y="4978720"/>
            <a:ext cx="4866772" cy="2790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FGFR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DLVS</a:t>
            </a:r>
            <a:r>
              <a:rPr lang="pl-PL" sz="1200" i="0" u="sng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C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YQVAR</a:t>
            </a:r>
            <a:r>
              <a:rPr lang="pl-PL" sz="1200" i="0" u="none" strike="noStrike" baseline="0" dirty="0">
                <a:latin typeface="Trebuchet MS" panose="020B0603020202020204" pitchFamily="34" charset="0"/>
              </a:rPr>
              <a:t>, MH+ 1281.6255, m/z 641.3164</a:t>
            </a:r>
            <a:r>
              <a:rPr lang="en-US" sz="1200" i="0" u="none" strike="noStrike" baseline="0" dirty="0">
                <a:latin typeface="Trebuchet MS" panose="020B0603020202020204" pitchFamily="34" charset="0"/>
              </a:rPr>
              <a:t>, charge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 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375E824-BF49-44BA-A416-B25101B4E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6082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84598733-C57E-4E7F-A797-76195EE0EA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0547" y="1021400"/>
            <a:ext cx="5896906" cy="365760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5FEB5A8E-55DC-40DA-8FB7-7DDB7E7AA9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615" y="5360720"/>
            <a:ext cx="5952838" cy="3657600"/>
          </a:xfrm>
          <a:prstGeom prst="rect">
            <a:avLst/>
          </a:prstGeom>
        </p:spPr>
      </p:pic>
      <p:sp>
        <p:nvSpPr>
          <p:cNvPr id="7" name="文字方塊 6">
            <a:extLst>
              <a:ext uri="{FF2B5EF4-FFF2-40B4-BE49-F238E27FC236}">
                <a16:creationId xmlns:a16="http://schemas.microsoft.com/office/drawing/2014/main" id="{79CC2240-90C5-41D8-B750-8031B792C3B8}"/>
              </a:ext>
            </a:extLst>
          </p:cNvPr>
          <p:cNvSpPr txBox="1"/>
          <p:nvPr/>
        </p:nvSpPr>
        <p:spPr>
          <a:xfrm>
            <a:off x="1106906" y="768465"/>
            <a:ext cx="4740443" cy="27699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ANO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YSTLPAED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051.5055, m/z 526.2564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 2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EB43B50E-20AB-48DF-A367-C166E6DFF28B}"/>
              </a:ext>
            </a:extLst>
          </p:cNvPr>
          <p:cNvSpPr txBox="1"/>
          <p:nvPr/>
        </p:nvSpPr>
        <p:spPr>
          <a:xfrm>
            <a:off x="1004639" y="5119817"/>
            <a:ext cx="4866774" cy="27699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ASHP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EGIESGDPGTDDG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404.5874, m/z 702.7973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F9CC325-947A-4DC3-9361-A58D26ABE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52827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9C59F921-FEBC-4286-A9E4-FF616A4564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801" y="1016866"/>
            <a:ext cx="5922398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BA4674D3-A27B-4B2B-A075-83031D49E0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801" y="5293620"/>
            <a:ext cx="5938968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79D13556-C958-43EC-B76F-3124D1CC5977}"/>
              </a:ext>
            </a:extLst>
          </p:cNvPr>
          <p:cNvSpPr txBox="1"/>
          <p:nvPr/>
        </p:nvSpPr>
        <p:spPr>
          <a:xfrm>
            <a:off x="956511" y="739867"/>
            <a:ext cx="494497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CTNND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SLDNNYSTPNE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409.6292, m/z 705.318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CC692911-8F75-47D7-94FD-167DB43BBEE2}"/>
              </a:ext>
            </a:extLst>
          </p:cNvPr>
          <p:cNvSpPr txBox="1"/>
          <p:nvPr/>
        </p:nvSpPr>
        <p:spPr>
          <a:xfrm>
            <a:off x="730918" y="4996841"/>
            <a:ext cx="53961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dirty="0">
                <a:effectLst/>
                <a:latin typeface="Trebuchet MS" panose="020B0603020202020204" pitchFamily="34" charset="0"/>
              </a:rPr>
              <a:t>TNFRSF21, </a:t>
            </a:r>
            <a:r>
              <a:rPr lang="en-US" sz="1200" i="0" dirty="0">
                <a:solidFill>
                  <a:srgbClr val="8B0000"/>
                </a:solidFill>
                <a:effectLst/>
                <a:latin typeface="Trebuchet MS" panose="020B0603020202020204" pitchFamily="34" charset="0"/>
              </a:rPr>
              <a:t>GPEASLAQLISALR</a:t>
            </a:r>
            <a:r>
              <a:rPr lang="en-US" sz="1200" i="0" dirty="0">
                <a:solidFill>
                  <a:srgbClr val="000000"/>
                </a:solidFill>
                <a:effectLst/>
                <a:latin typeface="Trebuchet MS" panose="020B0603020202020204" pitchFamily="34" charset="0"/>
              </a:rPr>
              <a:t>, MH+ 1425.8060, m/z 713.4066, charge: 2</a:t>
            </a:r>
            <a:endParaRPr lang="en-US" sz="1200" dirty="0"/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EAD0C377-F1B8-4EB4-A7F9-56A16CF66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445803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B1A95303-E855-434C-929E-05FCB7C1DE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4187" y="937052"/>
            <a:ext cx="5949625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F1FBAFD8-1E90-4BC4-839E-BD7EB55BFC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4187" y="5408329"/>
            <a:ext cx="5917493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14095B5B-9689-4093-BDDF-619A47911A65}"/>
              </a:ext>
            </a:extLst>
          </p:cNvPr>
          <p:cNvSpPr txBox="1"/>
          <p:nvPr/>
        </p:nvSpPr>
        <p:spPr>
          <a:xfrm>
            <a:off x="1139992" y="660053"/>
            <a:ext cx="45780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HSPBP1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LFAISCLV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49.6448, m/z 575.326, Charge: 2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B85A8EC6-B16B-42E8-B6C0-AF3F11CCA24F}"/>
              </a:ext>
            </a:extLst>
          </p:cNvPr>
          <p:cNvSpPr txBox="1"/>
          <p:nvPr/>
        </p:nvSpPr>
        <p:spPr>
          <a:xfrm>
            <a:off x="675269" y="5131330"/>
            <a:ext cx="564130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WWP1,</a:t>
            </a:r>
            <a:r>
              <a:rPr lang="zh-TW" altLang="en-US" sz="1200" i="0" u="none" strike="noStrike" baseline="0" dirty="0">
                <a:latin typeface="Trebuchet MS" panose="020B0603020202020204" pitchFamily="34" charset="0"/>
              </a:rPr>
              <a:t>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QQSGNANTETLPSGWEQR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2131.0163, m/z 1066.01108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A3404D9-ABE2-4EAC-85EA-01BB9E508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1159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DA6E7B02-2D7D-444C-B079-99BFA94BED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126" y="1122804"/>
            <a:ext cx="5944936" cy="365760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7D80FBA7-67BA-42EF-8EB9-C86B823D83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099" y="5394998"/>
            <a:ext cx="5913963" cy="3657600"/>
          </a:xfrm>
          <a:prstGeom prst="rect">
            <a:avLst/>
          </a:prstGeom>
        </p:spPr>
      </p:pic>
      <p:sp>
        <p:nvSpPr>
          <p:cNvPr id="7" name="文字方塊 6">
            <a:extLst>
              <a:ext uri="{FF2B5EF4-FFF2-40B4-BE49-F238E27FC236}">
                <a16:creationId xmlns:a16="http://schemas.microsoft.com/office/drawing/2014/main" id="{49F45111-CF38-464F-8C73-42C6C0954227}"/>
              </a:ext>
            </a:extLst>
          </p:cNvPr>
          <p:cNvSpPr txBox="1"/>
          <p:nvPr/>
        </p:nvSpPr>
        <p:spPr>
          <a:xfrm>
            <a:off x="986255" y="869869"/>
            <a:ext cx="4878805" cy="27699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/>
            <a:r>
              <a:rPr lang="en-US" altLang="zh-TW" sz="1200" dirty="0">
                <a:solidFill>
                  <a:srgbClr val="000000"/>
                </a:solidFill>
                <a:latin typeface="Trebuchet MS" panose="020B0603020202020204" pitchFamily="34" charset="0"/>
              </a:rPr>
              <a:t>ATP1A3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LNIPVSQVNP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236.7059, m/z 618.8566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661129EA-F766-4260-9366-CD381F239FC8}"/>
              </a:ext>
            </a:extLst>
          </p:cNvPr>
          <p:cNvSpPr txBox="1"/>
          <p:nvPr/>
        </p:nvSpPr>
        <p:spPr>
          <a:xfrm>
            <a:off x="1183437" y="5117999"/>
            <a:ext cx="4732088" cy="27699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MT-CO2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VVLPIEAPI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06.6932, m/z 553.850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: 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88EB9A0F-FA3F-4836-8BE8-89436682F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9411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8143D3DF-4642-4F0C-ADC9-7B3C364CC2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865" y="1078097"/>
            <a:ext cx="5854270" cy="365760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7B83DB22-9C47-4CBE-804E-B3E2DC0601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1865" y="5452712"/>
            <a:ext cx="5854270" cy="3604308"/>
          </a:xfrm>
          <a:prstGeom prst="rect">
            <a:avLst/>
          </a:prstGeom>
        </p:spPr>
      </p:pic>
      <p:sp>
        <p:nvSpPr>
          <p:cNvPr id="7" name="文字方塊 6">
            <a:extLst>
              <a:ext uri="{FF2B5EF4-FFF2-40B4-BE49-F238E27FC236}">
                <a16:creationId xmlns:a16="http://schemas.microsoft.com/office/drawing/2014/main" id="{22B1A9B2-2A67-4C93-BFA1-ABDD9075E170}"/>
              </a:ext>
            </a:extLst>
          </p:cNvPr>
          <p:cNvSpPr txBox="1"/>
          <p:nvPr/>
        </p:nvSpPr>
        <p:spPr>
          <a:xfrm>
            <a:off x="944477" y="861258"/>
            <a:ext cx="51435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SLC16A3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GGAVVDEGPTGV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185.6110, m/z 593.3091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B987813C-CC50-4973-BB94-841DA8A6B69C}"/>
              </a:ext>
            </a:extLst>
          </p:cNvPr>
          <p:cNvSpPr txBox="1"/>
          <p:nvPr/>
        </p:nvSpPr>
        <p:spPr>
          <a:xfrm>
            <a:off x="1021178" y="5175713"/>
            <a:ext cx="499009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SLC39A1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EQSGPSPLEET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329.6281, m/z 665.3177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7879EC5D-87F4-4907-9B58-E7BEF1364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4337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圖片 10">
            <a:extLst>
              <a:ext uri="{FF2B5EF4-FFF2-40B4-BE49-F238E27FC236}">
                <a16:creationId xmlns:a16="http://schemas.microsoft.com/office/drawing/2014/main" id="{32119734-F075-4A35-821E-A59741F6B9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4592" y="5384909"/>
            <a:ext cx="5888815" cy="3657600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8095C6BF-8602-486C-B625-A996C31647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8364" y="1111205"/>
            <a:ext cx="5901272" cy="3657600"/>
          </a:xfrm>
          <a:prstGeom prst="rect">
            <a:avLst/>
          </a:prstGeom>
        </p:spPr>
      </p:pic>
      <p:sp>
        <p:nvSpPr>
          <p:cNvPr id="7" name="文字方塊 6">
            <a:extLst>
              <a:ext uri="{FF2B5EF4-FFF2-40B4-BE49-F238E27FC236}">
                <a16:creationId xmlns:a16="http://schemas.microsoft.com/office/drawing/2014/main" id="{7AC5E9FB-15D5-4AE3-BF5B-4CA9DE081ED5}"/>
              </a:ext>
            </a:extLst>
          </p:cNvPr>
          <p:cNvSpPr txBox="1"/>
          <p:nvPr/>
        </p:nvSpPr>
        <p:spPr>
          <a:xfrm>
            <a:off x="1106902" y="894366"/>
            <a:ext cx="477653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XPOT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YSELTTVQQQLI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578.8486, m/z 789.9279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C73BCE9C-FDE4-41AE-85C6-AD4EB7D26064}"/>
              </a:ext>
            </a:extLst>
          </p:cNvPr>
          <p:cNvSpPr txBox="1"/>
          <p:nvPr/>
        </p:nvSpPr>
        <p:spPr>
          <a:xfrm>
            <a:off x="1106902" y="5143236"/>
            <a:ext cx="494646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0" u="none" strike="noStrike" baseline="0" dirty="0">
                <a:latin typeface="Trebuchet MS" panose="020B0603020202020204" pitchFamily="34" charset="0"/>
              </a:rPr>
              <a:t>ERBB2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VTSANIQEFAG</a:t>
            </a:r>
            <a:r>
              <a:rPr lang="en-US" sz="1200" i="0" u="sng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C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K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495.7209, m/z 748.3641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78FF7E7B-6CA4-450A-B55F-3FAEAB5F5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1592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BD4CCE4B-4A4E-4EAD-A6D3-115EACC265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362" y="1146549"/>
            <a:ext cx="5935275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748FEE33-A357-45AD-9B75-5E8D8517D6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653" y="5384267"/>
            <a:ext cx="5966691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2099748B-1E86-49E0-9AC1-353C8E29E983}"/>
              </a:ext>
            </a:extLst>
          </p:cNvPr>
          <p:cNvSpPr txBox="1"/>
          <p:nvPr/>
        </p:nvSpPr>
        <p:spPr>
          <a:xfrm>
            <a:off x="1211239" y="869550"/>
            <a:ext cx="469824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CTNNB1, </a:t>
            </a:r>
            <a:r>
              <a:rPr lang="sv-SE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LSVELTSSLFR</a:t>
            </a:r>
            <a:r>
              <a:rPr lang="sv-SE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251.6943, m/z 626.3508, charge: 2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405FDA18-C4BF-4C77-A5A0-119DD510A098}"/>
              </a:ext>
            </a:extLst>
          </p:cNvPr>
          <p:cNvSpPr txBox="1"/>
          <p:nvPr/>
        </p:nvSpPr>
        <p:spPr>
          <a:xfrm>
            <a:off x="950344" y="5111165"/>
            <a:ext cx="522003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i="0" u="none" strike="noStrike" baseline="0" dirty="0">
                <a:latin typeface="Trebuchet MS" panose="020B0603020202020204" pitchFamily="34" charset="0"/>
              </a:rPr>
              <a:t>FHL2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DNQNF</a:t>
            </a:r>
            <a:r>
              <a:rPr lang="pl-PL" sz="1200" i="0" u="sng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C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VP</a:t>
            </a:r>
            <a:r>
              <a:rPr lang="pl-PL" sz="1200" i="0" u="sng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C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YE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573.6409, m/z 787.3241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	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24B2A5EC-CED2-4ABD-95DB-F7D44DCF8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3578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085D4C9A-8CE4-471A-BE9F-AAA68B437D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105" y="1129159"/>
            <a:ext cx="5983211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C9F0C558-668B-4E06-856E-50A016B893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7693" y="5345755"/>
            <a:ext cx="5896623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98E860A3-AE5E-4850-BB41-DBDF057D2909}"/>
              </a:ext>
            </a:extLst>
          </p:cNvPr>
          <p:cNvSpPr txBox="1"/>
          <p:nvPr/>
        </p:nvSpPr>
        <p:spPr>
          <a:xfrm>
            <a:off x="920415" y="852160"/>
            <a:ext cx="530592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>
                <a:solidFill>
                  <a:srgbClr val="000000"/>
                </a:solidFill>
                <a:latin typeface="Trebuchet MS" panose="020B0603020202020204" pitchFamily="34" charset="0"/>
              </a:rPr>
              <a:t>NOTCH1, </a:t>
            </a:r>
            <a:r>
              <a:rPr lang="en-US" sz="1200" b="1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HGASCQNTHGGYR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387.5920, m/z 694.2996, charge</a:t>
            </a:r>
            <a:r>
              <a:rPr lang="en-US" altLang="zh-TW" sz="1200" b="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b="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b="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b="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A8DCF539-CE88-4D62-802C-879EAE493EE5}"/>
              </a:ext>
            </a:extLst>
          </p:cNvPr>
          <p:cNvSpPr txBox="1"/>
          <p:nvPr/>
        </p:nvSpPr>
        <p:spPr>
          <a:xfrm>
            <a:off x="1212180" y="5157261"/>
            <a:ext cx="472239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i="0" u="none" strike="noStrike" baseline="0" dirty="0">
                <a:latin typeface="Trebuchet MS" panose="020B0603020202020204" pitchFamily="34" charset="0"/>
              </a:rPr>
              <a:t>NOTCH3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GLGPQGPR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852.4686, m/z 426.7380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CB1F5E60-128C-4639-A087-2259F4E28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2069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6">
            <a:extLst>
              <a:ext uri="{FF2B5EF4-FFF2-40B4-BE49-F238E27FC236}">
                <a16:creationId xmlns:a16="http://schemas.microsoft.com/office/drawing/2014/main" id="{2AA45CD6-75C7-42F3-8A3A-889F3775B9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515" y="1032907"/>
            <a:ext cx="5913053" cy="36576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EF6D4E10-B5D2-4C8D-8F3A-16A5E260C7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3957" y="5336474"/>
            <a:ext cx="5907611" cy="365760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7882DFBB-BEB5-4C4A-8F8E-77D2EA7F0B2D}"/>
              </a:ext>
            </a:extLst>
          </p:cNvPr>
          <p:cNvSpPr txBox="1"/>
          <p:nvPr/>
        </p:nvSpPr>
        <p:spPr>
          <a:xfrm>
            <a:off x="755983" y="755908"/>
            <a:ext cx="556460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200" dirty="0">
                <a:solidFill>
                  <a:srgbClr val="000000"/>
                </a:solidFill>
                <a:latin typeface="Trebuchet MS" panose="020B0603020202020204" pitchFamily="34" charset="0"/>
              </a:rPr>
              <a:t>LRP10, </a:t>
            </a:r>
            <a:r>
              <a:rPr lang="en-US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SQVTPSAAPLEALDGGTGPAR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995.0142, m/z 998.0107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en-US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B5D49438-0D1D-4B85-B2B4-682279D54BBC}"/>
              </a:ext>
            </a:extLst>
          </p:cNvPr>
          <p:cNvSpPr txBox="1"/>
          <p:nvPr/>
        </p:nvSpPr>
        <p:spPr>
          <a:xfrm>
            <a:off x="1008645" y="5061009"/>
            <a:ext cx="50592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l-PL" sz="1200" i="0" u="none" strike="noStrike" baseline="0" dirty="0">
                <a:latin typeface="Trebuchet MS" panose="020B0603020202020204" pitchFamily="34" charset="0"/>
              </a:rPr>
              <a:t>HSP90AB2P</a:t>
            </a:r>
            <a:r>
              <a:rPr lang="en-US" sz="1200" i="0" u="none" strike="noStrike" baseline="0" dirty="0">
                <a:latin typeface="Trebuchet MS" panose="020B0603020202020204" pitchFamily="34" charset="0"/>
              </a:rPr>
              <a:t>, </a:t>
            </a:r>
            <a:r>
              <a:rPr lang="pl-PL" sz="1200" i="0" u="none" strike="noStrike" baseline="0" dirty="0">
                <a:solidFill>
                  <a:srgbClr val="8B0000"/>
                </a:solidFill>
                <a:latin typeface="Trebuchet MS" panose="020B0603020202020204" pitchFamily="34" charset="0"/>
              </a:rPr>
              <a:t>AKFENLCKFMK</a:t>
            </a:r>
            <a:r>
              <a:rPr lang="pl-PL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MH+ 1374.6908, m/z 687.8491</a:t>
            </a:r>
            <a:r>
              <a:rPr 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, charge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:</a:t>
            </a:r>
            <a:r>
              <a:rPr lang="zh-TW" altLang="en-US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 </a:t>
            </a:r>
            <a:r>
              <a:rPr lang="en-US" altLang="zh-TW" sz="1200" i="0" u="none" strike="noStrike" baseline="0" dirty="0">
                <a:solidFill>
                  <a:srgbClr val="000000"/>
                </a:solidFill>
                <a:latin typeface="Trebuchet MS" panose="020B0603020202020204" pitchFamily="34" charset="0"/>
              </a:rPr>
              <a:t>2</a:t>
            </a:r>
            <a:endParaRPr lang="pl-PL" sz="1200" i="0" u="none" strike="noStrike" baseline="0" dirty="0">
              <a:solidFill>
                <a:srgbClr val="000000"/>
              </a:solidFill>
              <a:latin typeface="Trebuchet MS" panose="020B0603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D86C55F-C840-4AE9-BB15-7A4362A9D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F723-AFBF-4798-AA17-5D9ED45B124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878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71</TotalTime>
  <Words>1079</Words>
  <Application>Microsoft Office PowerPoint</Application>
  <PresentationFormat>A4 Paper (210x297 mm)</PresentationFormat>
  <Paragraphs>94</Paragraphs>
  <Slides>3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1</vt:i4>
      </vt:variant>
    </vt:vector>
  </HeadingPairs>
  <TitlesOfParts>
    <vt:vector size="37" baseType="lpstr">
      <vt:lpstr>新細明體</vt:lpstr>
      <vt:lpstr>Arial</vt:lpstr>
      <vt:lpstr>Calibri</vt:lpstr>
      <vt:lpstr>Calibri Light</vt:lpstr>
      <vt:lpstr>Trebuchet MS</vt:lpstr>
      <vt:lpstr>Office 佈景主題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R752</dc:creator>
  <cp:lastModifiedBy>Pei-Shan Wu</cp:lastModifiedBy>
  <cp:revision>50</cp:revision>
  <dcterms:created xsi:type="dcterms:W3CDTF">2023-04-26T06:31:31Z</dcterms:created>
  <dcterms:modified xsi:type="dcterms:W3CDTF">2023-05-01T04:25:54Z</dcterms:modified>
</cp:coreProperties>
</file>